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71" r:id="rId2"/>
    <p:sldId id="370" r:id="rId3"/>
  </p:sldIdLst>
  <p:sldSz cx="6858000" cy="9144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ADAD"/>
    <a:srgbClr val="F94040"/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6AF5F1D-B6DE-4DC3-9028-871DCE75C7A9}" v="2" dt="2022-03-21T21:31:37.3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4" d="100"/>
          <a:sy n="64" d="100"/>
        </p:scale>
        <p:origin x="2981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926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086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358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095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081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651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524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82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081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253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869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313006-87FF-449F-BF6C-AD734B8E1037}" type="datetimeFigureOut">
              <a:rPr lang="en-US" smtClean="0"/>
              <a:t>3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9A94F-5585-4E86-AAA1-AA0FF7C5E9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575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>
            <a:extLst>
              <a:ext uri="{FF2B5EF4-FFF2-40B4-BE49-F238E27FC236}">
                <a16:creationId xmlns:a16="http://schemas.microsoft.com/office/drawing/2014/main" id="{836BE3A1-217C-41E5-AD5F-14D4A3BE3746}"/>
              </a:ext>
            </a:extLst>
          </p:cNvPr>
          <p:cNvGrpSpPr/>
          <p:nvPr/>
        </p:nvGrpSpPr>
        <p:grpSpPr>
          <a:xfrm>
            <a:off x="359141" y="591447"/>
            <a:ext cx="6115407" cy="1722809"/>
            <a:chOff x="258247" y="1913196"/>
            <a:chExt cx="6115407" cy="1722809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ED31580-2DE5-45A6-879A-BE47581C66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21343"/>
            <a:stretch/>
          </p:blipFill>
          <p:spPr>
            <a:xfrm>
              <a:off x="484346" y="1981200"/>
              <a:ext cx="5889308" cy="1439603"/>
            </a:xfrm>
            <a:prstGeom prst="rect">
              <a:avLst/>
            </a:prstGeom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AE8F7A0D-759B-4EE3-A081-CBBF3F1EAB60}"/>
                </a:ext>
              </a:extLst>
            </p:cNvPr>
            <p:cNvGrpSpPr/>
            <p:nvPr/>
          </p:nvGrpSpPr>
          <p:grpSpPr>
            <a:xfrm>
              <a:off x="258247" y="2463033"/>
              <a:ext cx="1181483" cy="1172972"/>
              <a:chOff x="258247" y="2463033"/>
              <a:chExt cx="1181483" cy="1172972"/>
            </a:xfrm>
          </p:grpSpPr>
          <p:cxnSp>
            <p:nvCxnSpPr>
              <p:cNvPr id="10" name="Straight Arrow Connector 9">
                <a:extLst>
                  <a:ext uri="{FF2B5EF4-FFF2-40B4-BE49-F238E27FC236}">
                    <a16:creationId xmlns:a16="http://schemas.microsoft.com/office/drawing/2014/main" id="{2FE0B2BE-166A-490E-9C27-57051A37E8E7}"/>
                  </a:ext>
                </a:extLst>
              </p:cNvPr>
              <p:cNvCxnSpPr/>
              <p:nvPr/>
            </p:nvCxnSpPr>
            <p:spPr>
              <a:xfrm>
                <a:off x="381000" y="3505200"/>
                <a:ext cx="4572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Arrow Connector 10">
                <a:extLst>
                  <a:ext uri="{FF2B5EF4-FFF2-40B4-BE49-F238E27FC236}">
                    <a16:creationId xmlns:a16="http://schemas.microsoft.com/office/drawing/2014/main" id="{E4E4DA77-B12B-45FD-9915-612CBFFF540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84110" y="3048000"/>
                <a:ext cx="0" cy="4572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3E9318A-A709-481A-A692-C7E71DAEF43B}"/>
                  </a:ext>
                </a:extLst>
              </p:cNvPr>
              <p:cNvSpPr txBox="1"/>
              <p:nvPr/>
            </p:nvSpPr>
            <p:spPr>
              <a:xfrm>
                <a:off x="772884" y="3374395"/>
                <a:ext cx="6668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0D1D661-0916-4A9F-8F53-AE099C95013A}"/>
                  </a:ext>
                </a:extLst>
              </p:cNvPr>
              <p:cNvSpPr txBox="1"/>
              <p:nvPr/>
            </p:nvSpPr>
            <p:spPr>
              <a:xfrm rot="16200000">
                <a:off x="55629" y="2665651"/>
                <a:ext cx="6668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252FE993-31F4-4D6F-A111-63D124FB5457}"/>
                </a:ext>
              </a:extLst>
            </p:cNvPr>
            <p:cNvGrpSpPr/>
            <p:nvPr/>
          </p:nvGrpSpPr>
          <p:grpSpPr>
            <a:xfrm>
              <a:off x="1804973" y="2463033"/>
              <a:ext cx="1181483" cy="1172972"/>
              <a:chOff x="1804973" y="2463033"/>
              <a:chExt cx="1181483" cy="1172972"/>
            </a:xfrm>
          </p:grpSpPr>
          <p:cxnSp>
            <p:nvCxnSpPr>
              <p:cNvPr id="15" name="Straight Arrow Connector 14">
                <a:extLst>
                  <a:ext uri="{FF2B5EF4-FFF2-40B4-BE49-F238E27FC236}">
                    <a16:creationId xmlns:a16="http://schemas.microsoft.com/office/drawing/2014/main" id="{8198CB58-40AB-4186-81A5-6BF5D97B02F5}"/>
                  </a:ext>
                </a:extLst>
              </p:cNvPr>
              <p:cNvCxnSpPr/>
              <p:nvPr/>
            </p:nvCxnSpPr>
            <p:spPr>
              <a:xfrm>
                <a:off x="1927726" y="3505200"/>
                <a:ext cx="4572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Arrow Connector 15">
                <a:extLst>
                  <a:ext uri="{FF2B5EF4-FFF2-40B4-BE49-F238E27FC236}">
                    <a16:creationId xmlns:a16="http://schemas.microsoft.com/office/drawing/2014/main" id="{A85F702E-9BCE-4735-B603-B70FC288964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930836" y="3048000"/>
                <a:ext cx="0" cy="4572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79F45DE4-BA8B-47B0-ABF2-68646C4A9CDD}"/>
                  </a:ext>
                </a:extLst>
              </p:cNvPr>
              <p:cNvSpPr txBox="1"/>
              <p:nvPr/>
            </p:nvSpPr>
            <p:spPr>
              <a:xfrm>
                <a:off x="2319610" y="3374395"/>
                <a:ext cx="6668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880F56B-2F13-4B5D-9879-7F68F02E2996}"/>
                  </a:ext>
                </a:extLst>
              </p:cNvPr>
              <p:cNvSpPr txBox="1"/>
              <p:nvPr/>
            </p:nvSpPr>
            <p:spPr>
              <a:xfrm rot="16200000">
                <a:off x="1602355" y="2665651"/>
                <a:ext cx="6668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H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A78A99E6-48C5-437A-99DE-C101F5357AE5}"/>
                </a:ext>
              </a:extLst>
            </p:cNvPr>
            <p:cNvGrpSpPr/>
            <p:nvPr/>
          </p:nvGrpSpPr>
          <p:grpSpPr>
            <a:xfrm>
              <a:off x="3344931" y="1913196"/>
              <a:ext cx="1181482" cy="1722809"/>
              <a:chOff x="3344931" y="1828799"/>
              <a:chExt cx="1181482" cy="1722809"/>
            </a:xfrm>
          </p:grpSpPr>
          <p:cxnSp>
            <p:nvCxnSpPr>
              <p:cNvPr id="19" name="Straight Arrow Connector 18">
                <a:extLst>
                  <a:ext uri="{FF2B5EF4-FFF2-40B4-BE49-F238E27FC236}">
                    <a16:creationId xmlns:a16="http://schemas.microsoft.com/office/drawing/2014/main" id="{420428A0-342D-480D-86C5-DE16AC1D7120}"/>
                  </a:ext>
                </a:extLst>
              </p:cNvPr>
              <p:cNvCxnSpPr/>
              <p:nvPr/>
            </p:nvCxnSpPr>
            <p:spPr>
              <a:xfrm>
                <a:off x="3467683" y="3420803"/>
                <a:ext cx="4572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7FCED130-6AC3-47BF-A912-8B2BEC87F34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470793" y="2963603"/>
                <a:ext cx="0" cy="4572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D7AE210-3475-4948-9204-F0BBBA9053CC}"/>
                  </a:ext>
                </a:extLst>
              </p:cNvPr>
              <p:cNvSpPr txBox="1"/>
              <p:nvPr/>
            </p:nvSpPr>
            <p:spPr>
              <a:xfrm>
                <a:off x="3859567" y="3289998"/>
                <a:ext cx="6668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CB3079B-D73C-4E66-81D5-91DD368B2DF2}"/>
                  </a:ext>
                </a:extLst>
              </p:cNvPr>
              <p:cNvSpPr txBox="1"/>
              <p:nvPr/>
            </p:nvSpPr>
            <p:spPr>
              <a:xfrm rot="16200000">
                <a:off x="2867394" y="2306336"/>
                <a:ext cx="121668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Zombie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qua</a:t>
                </a: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EC7E47FB-7222-4C7C-88E8-387E4B6047A1}"/>
                </a:ext>
              </a:extLst>
            </p:cNvPr>
            <p:cNvGrpSpPr/>
            <p:nvPr/>
          </p:nvGrpSpPr>
          <p:grpSpPr>
            <a:xfrm>
              <a:off x="4875160" y="2463033"/>
              <a:ext cx="1181483" cy="1172972"/>
              <a:chOff x="4875160" y="2361147"/>
              <a:chExt cx="1181483" cy="1172972"/>
            </a:xfrm>
          </p:grpSpPr>
          <p:cxnSp>
            <p:nvCxnSpPr>
              <p:cNvPr id="24" name="Straight Arrow Connector 23">
                <a:extLst>
                  <a:ext uri="{FF2B5EF4-FFF2-40B4-BE49-F238E27FC236}">
                    <a16:creationId xmlns:a16="http://schemas.microsoft.com/office/drawing/2014/main" id="{0FB9F8C8-D2A5-4156-957D-2F8778D38F55}"/>
                  </a:ext>
                </a:extLst>
              </p:cNvPr>
              <p:cNvCxnSpPr/>
              <p:nvPr/>
            </p:nvCxnSpPr>
            <p:spPr>
              <a:xfrm>
                <a:off x="4997913" y="3403314"/>
                <a:ext cx="4572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>
                <a:extLst>
                  <a:ext uri="{FF2B5EF4-FFF2-40B4-BE49-F238E27FC236}">
                    <a16:creationId xmlns:a16="http://schemas.microsoft.com/office/drawing/2014/main" id="{75B81D1B-D753-4F7F-AB3E-CB1C454B66D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01023" y="2946114"/>
                <a:ext cx="0" cy="4572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B4F56904-2E63-4C78-B1B0-AC8BDDB3E496}"/>
                  </a:ext>
                </a:extLst>
              </p:cNvPr>
              <p:cNvSpPr txBox="1"/>
              <p:nvPr/>
            </p:nvSpPr>
            <p:spPr>
              <a:xfrm>
                <a:off x="5389797" y="3272509"/>
                <a:ext cx="6668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055E10B7-E620-4B50-B37C-19507A5C9B2C}"/>
                  </a:ext>
                </a:extLst>
              </p:cNvPr>
              <p:cNvSpPr txBox="1"/>
              <p:nvPr/>
            </p:nvSpPr>
            <p:spPr>
              <a:xfrm rot="16200000">
                <a:off x="4672542" y="2563765"/>
                <a:ext cx="6668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</p:grp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F41F04AD-AEF6-4395-B30D-FADA8F60026D}"/>
                </a:ext>
              </a:extLst>
            </p:cNvPr>
            <p:cNvCxnSpPr/>
            <p:nvPr/>
          </p:nvCxnSpPr>
          <p:spPr>
            <a:xfrm>
              <a:off x="1524000" y="2133600"/>
              <a:ext cx="4572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BF8D3293-7D6C-4A97-8E6F-92768CBC6B1D}"/>
                </a:ext>
              </a:extLst>
            </p:cNvPr>
            <p:cNvCxnSpPr/>
            <p:nvPr/>
          </p:nvCxnSpPr>
          <p:spPr>
            <a:xfrm>
              <a:off x="3059151" y="2133600"/>
              <a:ext cx="4572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82F099DA-F1E2-4A23-9CB2-AD9690215B44}"/>
                </a:ext>
              </a:extLst>
            </p:cNvPr>
            <p:cNvCxnSpPr/>
            <p:nvPr/>
          </p:nvCxnSpPr>
          <p:spPr>
            <a:xfrm>
              <a:off x="4560849" y="2133600"/>
              <a:ext cx="4572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2ADF182B-1A37-4451-B847-B10C5BA8BB24}"/>
              </a:ext>
            </a:extLst>
          </p:cNvPr>
          <p:cNvGrpSpPr/>
          <p:nvPr/>
        </p:nvGrpSpPr>
        <p:grpSpPr>
          <a:xfrm>
            <a:off x="5109337" y="2745575"/>
            <a:ext cx="1879216" cy="1901555"/>
            <a:chOff x="5008443" y="3904890"/>
            <a:chExt cx="1879216" cy="1901555"/>
          </a:xfrm>
        </p:grpSpPr>
        <p:graphicFrame>
          <p:nvGraphicFramePr>
            <p:cNvPr id="42" name="Object 41">
              <a:extLst>
                <a:ext uri="{FF2B5EF4-FFF2-40B4-BE49-F238E27FC236}">
                  <a16:creationId xmlns:a16="http://schemas.microsoft.com/office/drawing/2014/main" id="{D71F69E7-F2F8-4D7C-B965-E26367688D4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67890665"/>
                </p:ext>
              </p:extLst>
            </p:nvPr>
          </p:nvGraphicFramePr>
          <p:xfrm>
            <a:off x="5341866" y="3982625"/>
            <a:ext cx="1545793" cy="18238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Prism 8" r:id="rId4" imgW="2061057" imgH="2431760" progId="Prism8.Document">
                    <p:embed/>
                  </p:oleObj>
                </mc:Choice>
                <mc:Fallback>
                  <p:oleObj name="Prism 8" r:id="rId4" imgW="2061057" imgH="2431760" progId="Prism8.Document">
                    <p:embed/>
                    <p:pic>
                      <p:nvPicPr>
                        <p:cNvPr id="42" name="Object 41">
                          <a:extLst>
                            <a:ext uri="{FF2B5EF4-FFF2-40B4-BE49-F238E27FC236}">
                              <a16:creationId xmlns:a16="http://schemas.microsoft.com/office/drawing/2014/main" id="{D71F69E7-F2F8-4D7C-B965-E26367688D4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341866" y="3982625"/>
                          <a:ext cx="1545793" cy="18238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B616FE3-231A-4F90-80FE-DBB69CDDB0D4}"/>
                </a:ext>
              </a:extLst>
            </p:cNvPr>
            <p:cNvSpPr txBox="1"/>
            <p:nvPr/>
          </p:nvSpPr>
          <p:spPr>
            <a:xfrm>
              <a:off x="5008443" y="5074499"/>
              <a:ext cx="6668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BB0C17D-0A12-4C94-8E4A-480F44A8A0C9}"/>
                </a:ext>
              </a:extLst>
            </p:cNvPr>
            <p:cNvSpPr txBox="1"/>
            <p:nvPr/>
          </p:nvSpPr>
          <p:spPr>
            <a:xfrm rot="16200000">
              <a:off x="4715775" y="4729036"/>
              <a:ext cx="117198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% Ki67</a:t>
              </a:r>
              <a:r>
                <a:rPr lang="en-US" sz="1400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+ 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r>
                <a:rPr lang="en-U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0222DA8B-49FF-47DA-BDD6-3E8216418841}"/>
                </a:ext>
              </a:extLst>
            </p:cNvPr>
            <p:cNvCxnSpPr/>
            <p:nvPr/>
          </p:nvCxnSpPr>
          <p:spPr>
            <a:xfrm>
              <a:off x="5832542" y="4946029"/>
              <a:ext cx="27432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0D082AE8-6537-4102-8A1A-C5EF0BEF8886}"/>
                </a:ext>
              </a:extLst>
            </p:cNvPr>
            <p:cNvCxnSpPr/>
            <p:nvPr/>
          </p:nvCxnSpPr>
          <p:spPr>
            <a:xfrm>
              <a:off x="6102076" y="4940839"/>
              <a:ext cx="0" cy="731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862FE3F-196B-4A32-88ED-6D369ABCD756}"/>
                </a:ext>
              </a:extLst>
            </p:cNvPr>
            <p:cNvSpPr txBox="1"/>
            <p:nvPr/>
          </p:nvSpPr>
          <p:spPr>
            <a:xfrm>
              <a:off x="5773044" y="4789353"/>
              <a:ext cx="4160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2222F2B9-8399-4B33-833E-FDB01FE6A052}"/>
                </a:ext>
              </a:extLst>
            </p:cNvPr>
            <p:cNvCxnSpPr/>
            <p:nvPr/>
          </p:nvCxnSpPr>
          <p:spPr>
            <a:xfrm>
              <a:off x="5840640" y="4946029"/>
              <a:ext cx="0" cy="731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33989E1E-4405-419A-B39B-EF14260AAA33}"/>
                </a:ext>
              </a:extLst>
            </p:cNvPr>
            <p:cNvCxnSpPr/>
            <p:nvPr/>
          </p:nvCxnSpPr>
          <p:spPr>
            <a:xfrm>
              <a:off x="5843274" y="4064891"/>
              <a:ext cx="54864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413FFE97-EA31-4637-A6B9-8A87F900750B}"/>
                </a:ext>
              </a:extLst>
            </p:cNvPr>
            <p:cNvCxnSpPr/>
            <p:nvPr/>
          </p:nvCxnSpPr>
          <p:spPr>
            <a:xfrm>
              <a:off x="6387420" y="4057207"/>
              <a:ext cx="0" cy="731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F1125DE-957B-4467-9CF3-E27F784FCFE1}"/>
                </a:ext>
              </a:extLst>
            </p:cNvPr>
            <p:cNvSpPr txBox="1"/>
            <p:nvPr/>
          </p:nvSpPr>
          <p:spPr>
            <a:xfrm>
              <a:off x="5745079" y="3904890"/>
              <a:ext cx="7616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1B69C224-5B7C-47B8-B25E-707E97E23194}"/>
                </a:ext>
              </a:extLst>
            </p:cNvPr>
            <p:cNvCxnSpPr/>
            <p:nvPr/>
          </p:nvCxnSpPr>
          <p:spPr>
            <a:xfrm>
              <a:off x="5843132" y="4064891"/>
              <a:ext cx="0" cy="731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EDCDF9C-3030-4086-8AF2-F6BEAEE35279}"/>
                </a:ext>
              </a:extLst>
            </p:cNvPr>
            <p:cNvSpPr txBox="1"/>
            <p:nvPr/>
          </p:nvSpPr>
          <p:spPr>
            <a:xfrm>
              <a:off x="5008443" y="4734968"/>
              <a:ext cx="6668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B39CDEB-EE59-455B-8A0F-EB5866B7C8AD}"/>
                </a:ext>
              </a:extLst>
            </p:cNvPr>
            <p:cNvSpPr txBox="1"/>
            <p:nvPr/>
          </p:nvSpPr>
          <p:spPr>
            <a:xfrm>
              <a:off x="5008443" y="4395437"/>
              <a:ext cx="6668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483ADCF-819E-4D99-82FF-B2586D39CF60}"/>
                </a:ext>
              </a:extLst>
            </p:cNvPr>
            <p:cNvSpPr txBox="1"/>
            <p:nvPr/>
          </p:nvSpPr>
          <p:spPr>
            <a:xfrm>
              <a:off x="5008443" y="4055906"/>
              <a:ext cx="6668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710CD9E2-8D10-4C5F-A369-43BD85CE1C3F}"/>
                </a:ext>
              </a:extLst>
            </p:cNvPr>
            <p:cNvSpPr txBox="1"/>
            <p:nvPr/>
          </p:nvSpPr>
          <p:spPr>
            <a:xfrm>
              <a:off x="5008443" y="5414031"/>
              <a:ext cx="6668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FA76AF9D-2E93-402F-B9B0-A2C7E813BFAA}"/>
                </a:ext>
              </a:extLst>
            </p:cNvPr>
            <p:cNvCxnSpPr/>
            <p:nvPr/>
          </p:nvCxnSpPr>
          <p:spPr>
            <a:xfrm>
              <a:off x="6099992" y="4201853"/>
              <a:ext cx="27432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9BBCC2DC-E987-4B46-92C0-75D6AD5BDFB2}"/>
                </a:ext>
              </a:extLst>
            </p:cNvPr>
            <p:cNvCxnSpPr/>
            <p:nvPr/>
          </p:nvCxnSpPr>
          <p:spPr>
            <a:xfrm>
              <a:off x="6369526" y="4197393"/>
              <a:ext cx="0" cy="731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CFC59DE-02C8-401C-96B0-9635668FBBA3}"/>
                </a:ext>
              </a:extLst>
            </p:cNvPr>
            <p:cNvSpPr txBox="1"/>
            <p:nvPr/>
          </p:nvSpPr>
          <p:spPr>
            <a:xfrm>
              <a:off x="6037270" y="4059793"/>
              <a:ext cx="4160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A9046B76-5623-4CEA-A58F-352CB914808C}"/>
                </a:ext>
              </a:extLst>
            </p:cNvPr>
            <p:cNvCxnSpPr/>
            <p:nvPr/>
          </p:nvCxnSpPr>
          <p:spPr>
            <a:xfrm>
              <a:off x="6108090" y="4201853"/>
              <a:ext cx="0" cy="731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1" name="TextBox 70">
            <a:extLst>
              <a:ext uri="{FF2B5EF4-FFF2-40B4-BE49-F238E27FC236}">
                <a16:creationId xmlns:a16="http://schemas.microsoft.com/office/drawing/2014/main" id="{198EDAEF-E5FD-4D33-9DED-A4670766D507}"/>
              </a:ext>
            </a:extLst>
          </p:cNvPr>
          <p:cNvSpPr txBox="1"/>
          <p:nvPr/>
        </p:nvSpPr>
        <p:spPr>
          <a:xfrm>
            <a:off x="5070517" y="253029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068EC135-3606-4098-8319-2FAC568723C0}"/>
              </a:ext>
            </a:extLst>
          </p:cNvPr>
          <p:cNvSpPr txBox="1"/>
          <p:nvPr/>
        </p:nvSpPr>
        <p:spPr>
          <a:xfrm>
            <a:off x="306120" y="253029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3725DF-1C87-496A-AABE-5E62D3BB03E5}"/>
              </a:ext>
            </a:extLst>
          </p:cNvPr>
          <p:cNvSpPr txBox="1"/>
          <p:nvPr/>
        </p:nvSpPr>
        <p:spPr>
          <a:xfrm>
            <a:off x="306120" y="44151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6A365E78-57A7-4D08-B271-4734D05BAA5B}"/>
              </a:ext>
            </a:extLst>
          </p:cNvPr>
          <p:cNvGrpSpPr/>
          <p:nvPr/>
        </p:nvGrpSpPr>
        <p:grpSpPr>
          <a:xfrm>
            <a:off x="329494" y="2617151"/>
            <a:ext cx="4423870" cy="2158402"/>
            <a:chOff x="228600" y="3834125"/>
            <a:chExt cx="4423870" cy="2158402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2CA0925F-AEE9-43B3-A5C7-05B3C1D00F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b="25049"/>
            <a:stretch/>
          </p:blipFill>
          <p:spPr>
            <a:xfrm>
              <a:off x="483734" y="4199004"/>
              <a:ext cx="4167188" cy="1524194"/>
            </a:xfrm>
            <a:prstGeom prst="rect">
              <a:avLst/>
            </a:prstGeom>
          </p:spPr>
        </p:pic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D23BCB79-46EB-4BAD-AF08-E0074E15C8D1}"/>
                </a:ext>
              </a:extLst>
            </p:cNvPr>
            <p:cNvCxnSpPr/>
            <p:nvPr/>
          </p:nvCxnSpPr>
          <p:spPr>
            <a:xfrm>
              <a:off x="351353" y="5861722"/>
              <a:ext cx="4572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6FD602B1-4252-4161-960C-E9C5E282E5A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4463" y="5404522"/>
              <a:ext cx="0" cy="4572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844CB93-DD7F-428E-87BB-B141853FDB54}"/>
                </a:ext>
              </a:extLst>
            </p:cNvPr>
            <p:cNvSpPr txBox="1"/>
            <p:nvPr/>
          </p:nvSpPr>
          <p:spPr>
            <a:xfrm>
              <a:off x="743237" y="5730917"/>
              <a:ext cx="6668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C1EA827-D318-4030-B591-AADDF2F078E2}"/>
                </a:ext>
              </a:extLst>
            </p:cNvPr>
            <p:cNvSpPr txBox="1"/>
            <p:nvPr/>
          </p:nvSpPr>
          <p:spPr>
            <a:xfrm rot="16200000">
              <a:off x="25982" y="5022173"/>
              <a:ext cx="6668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9D9DBD2-9264-4587-8719-027E1750CA6C}"/>
                </a:ext>
              </a:extLst>
            </p:cNvPr>
            <p:cNvSpPr txBox="1"/>
            <p:nvPr/>
          </p:nvSpPr>
          <p:spPr>
            <a:xfrm>
              <a:off x="732086" y="4052861"/>
              <a:ext cx="12116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on-Tx; Spleen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22C055D-0154-47A5-989F-7213958C3DB4}"/>
                </a:ext>
              </a:extLst>
            </p:cNvPr>
            <p:cNvSpPr txBox="1"/>
            <p:nvPr/>
          </p:nvSpPr>
          <p:spPr>
            <a:xfrm>
              <a:off x="2076212" y="4052861"/>
              <a:ext cx="122800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kin Tx; Spleen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76BD9F75-84B5-41FA-B6B7-248A951357FC}"/>
                </a:ext>
              </a:extLst>
            </p:cNvPr>
            <p:cNvSpPr txBox="1"/>
            <p:nvPr/>
          </p:nvSpPr>
          <p:spPr>
            <a:xfrm>
              <a:off x="3424462" y="4052861"/>
              <a:ext cx="122800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kin Tx; Graft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9A7C38A5-FCDE-40FB-A56D-9A6EC7BBF7B0}"/>
                </a:ext>
              </a:extLst>
            </p:cNvPr>
            <p:cNvSpPr txBox="1"/>
            <p:nvPr/>
          </p:nvSpPr>
          <p:spPr>
            <a:xfrm>
              <a:off x="772177" y="3834125"/>
              <a:ext cx="20364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ated on live CD8</a:t>
              </a:r>
              <a:r>
                <a:rPr lang="en-U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T cells</a:t>
              </a:r>
            </a:p>
          </p:txBody>
        </p: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2158716A-53A8-4C09-890D-CC2D937B2318}"/>
              </a:ext>
            </a:extLst>
          </p:cNvPr>
          <p:cNvSpPr txBox="1"/>
          <p:nvPr/>
        </p:nvSpPr>
        <p:spPr>
          <a:xfrm>
            <a:off x="4605549" y="8573057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B29B3E8-5A21-4A7B-9788-DA146547AEC7}"/>
              </a:ext>
            </a:extLst>
          </p:cNvPr>
          <p:cNvSpPr txBox="1"/>
          <p:nvPr/>
        </p:nvSpPr>
        <p:spPr>
          <a:xfrm>
            <a:off x="609600" y="5105400"/>
            <a:ext cx="588930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Graft-infiltrating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highly express Ki67 and PD-1. Wild-type B6 recipients were transplanted with Balb/c skin allografts or left untransplanted on day 0. Eight days post skin transplantation, the expression levels of Ki67 and PD-1 of the splenic and graft-infiltrating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were determined by flow cytometry. (A) Gating strategy to detect the live graft-infiltrating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. (B,C) representative contour plots and bar graph display the Ki67 and PD-1 express levels of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. Data represent the mean ± SD (n = 5). **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, ****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01; (unpaired Student’s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). </a:t>
            </a:r>
          </a:p>
        </p:txBody>
      </p:sp>
    </p:spTree>
    <p:extLst>
      <p:ext uri="{BB962C8B-B14F-4D97-AF65-F5344CB8AC3E}">
        <p14:creationId xmlns:p14="http://schemas.microsoft.com/office/powerpoint/2010/main" val="1501533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42">
            <a:extLst>
              <a:ext uri="{FF2B5EF4-FFF2-40B4-BE49-F238E27FC236}">
                <a16:creationId xmlns:a16="http://schemas.microsoft.com/office/drawing/2014/main" id="{A012E686-D723-4596-8895-B2F721CDE1E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3770"/>
          <a:stretch/>
        </p:blipFill>
        <p:spPr>
          <a:xfrm>
            <a:off x="485043" y="1799493"/>
            <a:ext cx="1771650" cy="1860245"/>
          </a:xfrm>
          <a:prstGeom prst="rect">
            <a:avLst/>
          </a:prstGeom>
        </p:spPr>
      </p:pic>
      <p:grpSp>
        <p:nvGrpSpPr>
          <p:cNvPr id="38" name="Group 37">
            <a:extLst>
              <a:ext uri="{FF2B5EF4-FFF2-40B4-BE49-F238E27FC236}">
                <a16:creationId xmlns:a16="http://schemas.microsoft.com/office/drawing/2014/main" id="{03A2672B-D0A1-4AC7-8D6A-83F4F689A4DF}"/>
              </a:ext>
            </a:extLst>
          </p:cNvPr>
          <p:cNvGrpSpPr/>
          <p:nvPr/>
        </p:nvGrpSpPr>
        <p:grpSpPr>
          <a:xfrm>
            <a:off x="235635" y="816892"/>
            <a:ext cx="6536406" cy="4126814"/>
            <a:chOff x="235635" y="816892"/>
            <a:chExt cx="6536406" cy="4126814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64A67482-B98F-434B-A08B-592161E40B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23898"/>
            <a:stretch/>
          </p:blipFill>
          <p:spPr>
            <a:xfrm>
              <a:off x="2426203" y="2693016"/>
              <a:ext cx="1771650" cy="1874518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1641911-C355-4647-81A4-2FE0E5C9D1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23770"/>
            <a:stretch/>
          </p:blipFill>
          <p:spPr>
            <a:xfrm>
              <a:off x="4248150" y="2693016"/>
              <a:ext cx="1771650" cy="186024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DDC25AC-F81D-4772-B8F5-F65A442193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37524"/>
            <a:stretch/>
          </p:blipFill>
          <p:spPr>
            <a:xfrm>
              <a:off x="2426203" y="946802"/>
              <a:ext cx="1771650" cy="1874514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A4C8A5D-43AE-44E0-AD89-9656227A20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b="23185"/>
            <a:stretch/>
          </p:blipFill>
          <p:spPr>
            <a:xfrm>
              <a:off x="4248150" y="946802"/>
              <a:ext cx="1771650" cy="1874514"/>
            </a:xfrm>
            <a:prstGeom prst="rect">
              <a:avLst/>
            </a:prstGeom>
          </p:spPr>
        </p:pic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7CED2AC9-3022-40E0-A129-D12EEFE9B9B7}"/>
                </a:ext>
              </a:extLst>
            </p:cNvPr>
            <p:cNvCxnSpPr>
              <a:cxnSpLocks/>
              <a:endCxn id="9" idx="1"/>
            </p:cNvCxnSpPr>
            <p:nvPr/>
          </p:nvCxnSpPr>
          <p:spPr>
            <a:xfrm flipV="1">
              <a:off x="1905000" y="1884059"/>
              <a:ext cx="521203" cy="43363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37262340-F7AF-4C1B-B0A6-06740EE8FEB5}"/>
                </a:ext>
              </a:extLst>
            </p:cNvPr>
            <p:cNvCxnSpPr>
              <a:cxnSpLocks/>
            </p:cNvCxnSpPr>
            <p:nvPr/>
          </p:nvCxnSpPr>
          <p:spPr>
            <a:xfrm>
              <a:off x="1639180" y="3029724"/>
              <a:ext cx="787023" cy="2252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80126C0A-3EC4-49E2-9205-0D0C9F159034}"/>
                </a:ext>
              </a:extLst>
            </p:cNvPr>
            <p:cNvGrpSpPr/>
            <p:nvPr/>
          </p:nvGrpSpPr>
          <p:grpSpPr>
            <a:xfrm>
              <a:off x="235635" y="2373923"/>
              <a:ext cx="1181482" cy="1545152"/>
              <a:chOff x="429552" y="3200397"/>
              <a:chExt cx="1181482" cy="1545152"/>
            </a:xfrm>
          </p:grpSpPr>
          <p:cxnSp>
            <p:nvCxnSpPr>
              <p:cNvPr id="19" name="Straight Arrow Connector 18">
                <a:extLst>
                  <a:ext uri="{FF2B5EF4-FFF2-40B4-BE49-F238E27FC236}">
                    <a16:creationId xmlns:a16="http://schemas.microsoft.com/office/drawing/2014/main" id="{38C33002-E7BD-489B-BEFC-1DBCCBD548C4}"/>
                  </a:ext>
                </a:extLst>
              </p:cNvPr>
              <p:cNvCxnSpPr/>
              <p:nvPr/>
            </p:nvCxnSpPr>
            <p:spPr>
              <a:xfrm>
                <a:off x="552304" y="4614744"/>
                <a:ext cx="4572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Arrow Connector 19">
                <a:extLst>
                  <a:ext uri="{FF2B5EF4-FFF2-40B4-BE49-F238E27FC236}">
                    <a16:creationId xmlns:a16="http://schemas.microsoft.com/office/drawing/2014/main" id="{3A238EB1-4BD1-49A7-831C-0108B2DCCAA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5414" y="4157544"/>
                <a:ext cx="0" cy="4572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71365369-DCE0-4A26-8CB2-A431B6E3CB33}"/>
                  </a:ext>
                </a:extLst>
              </p:cNvPr>
              <p:cNvSpPr txBox="1"/>
              <p:nvPr/>
            </p:nvSpPr>
            <p:spPr>
              <a:xfrm>
                <a:off x="944188" y="4483939"/>
                <a:ext cx="6668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.2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B72085F3-71D2-4D09-B90B-BC454B9A1F45}"/>
                  </a:ext>
                </a:extLst>
              </p:cNvPr>
              <p:cNvSpPr txBox="1"/>
              <p:nvPr/>
            </p:nvSpPr>
            <p:spPr>
              <a:xfrm rot="16200000">
                <a:off x="40844" y="3589105"/>
                <a:ext cx="103902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.1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A9806210-31AE-4037-A6DF-94D7D6C5EBA1}"/>
                </a:ext>
              </a:extLst>
            </p:cNvPr>
            <p:cNvGrpSpPr/>
            <p:nvPr/>
          </p:nvGrpSpPr>
          <p:grpSpPr>
            <a:xfrm>
              <a:off x="2080975" y="3387403"/>
              <a:ext cx="1181482" cy="1556303"/>
              <a:chOff x="429552" y="3406698"/>
              <a:chExt cx="1181482" cy="1556303"/>
            </a:xfrm>
          </p:grpSpPr>
          <p:cxnSp>
            <p:nvCxnSpPr>
              <p:cNvPr id="24" name="Straight Arrow Connector 23">
                <a:extLst>
                  <a:ext uri="{FF2B5EF4-FFF2-40B4-BE49-F238E27FC236}">
                    <a16:creationId xmlns:a16="http://schemas.microsoft.com/office/drawing/2014/main" id="{B2468967-F21C-46BB-A34F-7E64C50D680A}"/>
                  </a:ext>
                </a:extLst>
              </p:cNvPr>
              <p:cNvCxnSpPr/>
              <p:nvPr/>
            </p:nvCxnSpPr>
            <p:spPr>
              <a:xfrm>
                <a:off x="552304" y="4821045"/>
                <a:ext cx="4572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>
                <a:extLst>
                  <a:ext uri="{FF2B5EF4-FFF2-40B4-BE49-F238E27FC236}">
                    <a16:creationId xmlns:a16="http://schemas.microsoft.com/office/drawing/2014/main" id="{4774AB31-E860-4F3E-B71D-35F9D2E305B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5414" y="4363845"/>
                <a:ext cx="0" cy="4572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0A4855DF-7F46-464F-A7D2-EAAECC1B9B78}"/>
                  </a:ext>
                </a:extLst>
              </p:cNvPr>
              <p:cNvSpPr txBox="1"/>
              <p:nvPr/>
            </p:nvSpPr>
            <p:spPr>
              <a:xfrm>
                <a:off x="944188" y="4701391"/>
                <a:ext cx="66684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TV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57436C78-4255-44AD-80C7-C1855E3879FC}"/>
                  </a:ext>
                </a:extLst>
              </p:cNvPr>
              <p:cNvSpPr txBox="1"/>
              <p:nvPr/>
            </p:nvSpPr>
            <p:spPr>
              <a:xfrm rot="16200000">
                <a:off x="40844" y="3795406"/>
                <a:ext cx="103902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.1</a:t>
                </a:r>
              </a:p>
            </p:txBody>
          </p: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71C6445-C6C6-4F28-9D30-BEBD61EED5DB}"/>
                </a:ext>
              </a:extLst>
            </p:cNvPr>
            <p:cNvSpPr txBox="1"/>
            <p:nvPr/>
          </p:nvSpPr>
          <p:spPr>
            <a:xfrm>
              <a:off x="2743199" y="816892"/>
              <a:ext cx="145465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PL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831E51E-A521-49F5-A2CC-DC4D1EA8015F}"/>
                </a:ext>
              </a:extLst>
            </p:cNvPr>
            <p:cNvSpPr txBox="1"/>
            <p:nvPr/>
          </p:nvSpPr>
          <p:spPr>
            <a:xfrm>
              <a:off x="4521068" y="816892"/>
              <a:ext cx="15049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N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E33DE7E-33D9-4CC6-B2A0-23DED04CA12D}"/>
                </a:ext>
              </a:extLst>
            </p:cNvPr>
            <p:cNvSpPr txBox="1"/>
            <p:nvPr/>
          </p:nvSpPr>
          <p:spPr>
            <a:xfrm>
              <a:off x="5992853" y="1732155"/>
              <a:ext cx="6668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AE428FE-DF2C-4AEC-B0C5-2AEFB48837F1}"/>
                </a:ext>
              </a:extLst>
            </p:cNvPr>
            <p:cNvSpPr txBox="1"/>
            <p:nvPr/>
          </p:nvSpPr>
          <p:spPr>
            <a:xfrm>
              <a:off x="5992853" y="3457873"/>
              <a:ext cx="7791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ATF</a:t>
              </a:r>
              <a:r>
                <a:rPr lang="en-US" sz="1400" baseline="30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–/–</a:t>
              </a:r>
              <a:r>
                <a: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200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3E661467-6348-4E7C-9DAE-3507B615D940}"/>
              </a:ext>
            </a:extLst>
          </p:cNvPr>
          <p:cNvSpPr txBox="1"/>
          <p:nvPr/>
        </p:nvSpPr>
        <p:spPr>
          <a:xfrm>
            <a:off x="686841" y="1635369"/>
            <a:ext cx="15815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ated on live CD8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A8FCDCC-854A-438C-B3F6-4BA709788D81}"/>
              </a:ext>
            </a:extLst>
          </p:cNvPr>
          <p:cNvSpPr txBox="1"/>
          <p:nvPr/>
        </p:nvSpPr>
        <p:spPr>
          <a:xfrm>
            <a:off x="201258" y="16002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C486CEC-BB24-4E9A-8C4E-A41699045A3B}"/>
              </a:ext>
            </a:extLst>
          </p:cNvPr>
          <p:cNvSpPr txBox="1"/>
          <p:nvPr/>
        </p:nvSpPr>
        <p:spPr>
          <a:xfrm>
            <a:off x="4634314" y="8760023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6D050FA-A8E7-4BDE-ABF3-B4197FE2C09F}"/>
              </a:ext>
            </a:extLst>
          </p:cNvPr>
          <p:cNvSpPr txBox="1"/>
          <p:nvPr/>
        </p:nvSpPr>
        <p:spPr>
          <a:xfrm>
            <a:off x="350953" y="5179071"/>
            <a:ext cx="588930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BATF-deficient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display a defect in proliferation. CD45.1</a:t>
            </a:r>
            <a:r>
              <a:rPr lang="en-US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T and CD45.2</a:t>
            </a:r>
            <a:r>
              <a:rPr lang="en-US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TF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/–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were mixed in a 1:1 ratio, labelled with CTV, and adoptively transferred into B6.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g1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/–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that received Balb/c skins 1 day later. On day 7 post skin transplantation, the CTV fluorescence was determined by flow cytometry.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Left panel, representative plots for detecting the adoptively transferred CD45.1</a:t>
            </a:r>
            <a:r>
              <a:rPr lang="en-US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T and CD45.2</a:t>
            </a:r>
            <a:r>
              <a:rPr lang="en-US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TF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/–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; Middle and right panels, representative plots display the loss of CTV fluorescence in CD45.1</a:t>
            </a:r>
            <a:r>
              <a:rPr lang="en-US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T and CD45.2</a:t>
            </a:r>
            <a:r>
              <a:rPr lang="en-US" sz="1200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TF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/–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.</a:t>
            </a:r>
          </a:p>
        </p:txBody>
      </p:sp>
    </p:spTree>
    <p:extLst>
      <p:ext uri="{BB962C8B-B14F-4D97-AF65-F5344CB8AC3E}">
        <p14:creationId xmlns:p14="http://schemas.microsoft.com/office/powerpoint/2010/main" val="3327989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768</TotalTime>
  <Words>318</Words>
  <Application>Microsoft Office PowerPoint</Application>
  <PresentationFormat>On-screen Show (4:3)</PresentationFormat>
  <Paragraphs>41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Prism 8</vt:lpstr>
      <vt:lpstr>PowerPoint Presentation</vt:lpstr>
      <vt:lpstr>PowerPoint Presentation</vt:lpstr>
    </vt:vector>
  </TitlesOfParts>
  <Company>TM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Wenhao</dc:creator>
  <cp:lastModifiedBy>Li, Shuang</cp:lastModifiedBy>
  <cp:revision>614</cp:revision>
  <cp:lastPrinted>2022-02-28T16:43:14Z</cp:lastPrinted>
  <dcterms:created xsi:type="dcterms:W3CDTF">2018-09-24T21:21:26Z</dcterms:created>
  <dcterms:modified xsi:type="dcterms:W3CDTF">2022-03-21T23:31:46Z</dcterms:modified>
</cp:coreProperties>
</file>